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744"/>
  </p:normalViewPr>
  <p:slideViewPr>
    <p:cSldViewPr snapToGrid="0" snapToObjects="1">
      <p:cViewPr>
        <p:scale>
          <a:sx n="110" d="100"/>
          <a:sy n="110" d="100"/>
        </p:scale>
        <p:origin x="1176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6298D6-A554-8842-A579-23E81C04A020}" type="datetimeFigureOut">
              <a:rPr lang="en-US" smtClean="0"/>
              <a:t>2/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259C5A-2AA6-1F48-B1DF-4C6BDCA3A6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6291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259C5A-2AA6-1F48-B1DF-4C6BDCA3A69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6609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BC4B91-76FA-EC47-92F1-53417FDAAB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A8404D-80B4-2142-AF65-85318B733B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614B26-3461-B44D-BCA1-64882B627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A55E8-7B41-5740-934C-A5CCC527B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011F40-BC0F-3F40-8688-51003729D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4952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6BBF8-8FB7-604B-8809-4712EA21C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4E0D60-9A76-C348-B64B-0E2351FF0F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88D12A-55DD-9347-A1AA-9D9D1A891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D17B3A-FA6E-774F-80B5-87F745B55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C7D92F-89E3-B048-A7AF-E3DF71150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53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9A543A-46E3-5B4B-BE23-DE8F3482DF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EF28E0-FCF9-124E-A8E8-25BE221CB4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63FF5F-1C12-F446-8D58-398D79633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9ECC29-AB76-F64A-A53E-19EDAA11F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0D6223-ED8C-094E-A6D9-6782DD5D64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222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930D12-D266-A54C-AEE9-06DFE0B653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29DF68-C30F-E64F-89C4-343EA1E5F2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03A285-0BCD-924B-A3A1-D77BDC57A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4EE5B5-81E4-D24B-9540-66B99FD38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C023CA-D896-DF4C-9459-08FF38171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038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5F86C9-2C61-FF4C-AA5B-4F42D1F452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5B6D98-5CEC-0C41-9693-506BE8AD58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AD9825-55EC-7448-87FA-EC7CE16CA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15041-A611-2D44-A582-E5740168DD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1F492C-F300-C24C-979C-CC75F5A23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716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4F0F9-C1DB-BC4E-8F35-3973BE4DC9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93EB02-723F-B349-9D83-69D0A5ACDC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5FB7D7-9FB6-6443-B351-9BCD891B59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7B1A9F-9995-DB48-8922-58BF4DE1A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4E009A-9B8B-2C46-8CC7-740D60877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1BB8D0-9824-1441-B46D-BE8B4FDAC1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0072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FA7945-BFBA-4040-9B81-20117DFAA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12782D-4963-CE4F-A64E-9A271FD68E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183C0F-F286-594C-BB3A-078B9A4A61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E6F521-5120-D54F-9647-3B17C2C312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69B5CC-E954-2F45-A821-6CDF0EE162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5CD25B-2544-6A43-9327-3C042EDAB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34BF1A-22BD-A648-A8DF-911AD6B2B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5E052B-FFBD-9E4F-B114-B706BB14F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4615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E278EC-74FC-CF49-AB01-5D5265E150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2DAC5C-A04A-FE4F-8734-7B7EB5346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66A371-2706-5E45-A077-330F8A5C1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6C4450-224E-6141-97FE-DFE26922D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136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2FF489B-635D-4A4C-9406-9EC8746472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82CD32B-6012-2140-8DDF-B323EF156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B2BCFF-EE5A-8445-A938-F713ADF07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137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9F032-162D-F74C-B09C-779821CE1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C9C9FD-024D-404C-9F6D-52D682BEE1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433524-0D02-2D4F-989D-79DF2B6401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FA871F-2B1B-454D-889C-92E214289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60A8D9-BDFA-244A-8847-3C0E6B14F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05C197-9DE3-1E4E-88A6-63D4CED82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640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5489E1-D071-4142-A5C9-5E492EBDBB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CD97B1-ADE5-5C44-8454-EB427A0219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0DC456-7106-EF44-9E8E-02BAD09D7D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59E1EC-8F53-024F-9C9E-1F5E2E2B56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CF373B-8647-E14C-959B-F132D4C29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083702-0A47-664C-85A1-86556010F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460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54A339-4682-A64B-B4C1-369FA7623C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2C13A9-C587-D644-8528-E6B9C32A82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003CBF-4330-7D46-BFE0-062648010B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B5909-E2B4-8044-8EEC-3A492A2A31D8}" type="datetimeFigureOut">
              <a:rPr lang="en-US" smtClean="0"/>
              <a:t>2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6B7631-E200-BE40-B339-2A1FCE504C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5AE46-6D01-6544-89B8-C2DC953E52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6C6E5-E63B-A24F-ABA8-01CC660671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93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F81F23A-1696-B245-999B-19D3B70898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5600" y="765072"/>
            <a:ext cx="3860800" cy="3784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37E164C-4AF6-E445-A433-2D02E48E0EF5}"/>
              </a:ext>
            </a:extLst>
          </p:cNvPr>
          <p:cNvSpPr txBox="1"/>
          <p:nvPr/>
        </p:nvSpPr>
        <p:spPr>
          <a:xfrm>
            <a:off x="3424313" y="4702119"/>
            <a:ext cx="57086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1. Telomeric content within age groups</a:t>
            </a:r>
            <a:endParaRPr lang="en-US" dirty="0"/>
          </a:p>
          <a:p>
            <a:r>
              <a:rPr lang="en-US" dirty="0"/>
              <a:t>Boxplot showing the telomeric content of samples by age group. Analysis was restricted to samples that are non-altered in </a:t>
            </a:r>
            <a:r>
              <a:rPr lang="en-US" i="1" dirty="0"/>
              <a:t>ATRX</a:t>
            </a:r>
            <a:r>
              <a:rPr lang="en-US" dirty="0"/>
              <a:t>, </a:t>
            </a:r>
            <a:r>
              <a:rPr lang="en-US" i="1" dirty="0"/>
              <a:t>DAXX</a:t>
            </a:r>
            <a:r>
              <a:rPr lang="en-US" dirty="0"/>
              <a:t>, </a:t>
            </a:r>
            <a:r>
              <a:rPr lang="en-US" i="1" dirty="0" err="1"/>
              <a:t>TERTp</a:t>
            </a:r>
            <a:r>
              <a:rPr lang="en-US" dirty="0"/>
              <a:t>, </a:t>
            </a:r>
            <a:r>
              <a:rPr lang="en-US" i="1" dirty="0"/>
              <a:t>TERC</a:t>
            </a:r>
            <a:r>
              <a:rPr lang="en-US" dirty="0"/>
              <a:t>, </a:t>
            </a:r>
            <a:r>
              <a:rPr lang="en-US" i="1" dirty="0"/>
              <a:t>RAD21</a:t>
            </a:r>
            <a:r>
              <a:rPr lang="en-US" dirty="0"/>
              <a:t>, and </a:t>
            </a:r>
            <a:r>
              <a:rPr lang="en-US" i="1" dirty="0"/>
              <a:t>HGF</a:t>
            </a:r>
            <a:r>
              <a:rPr lang="en-US" dirty="0"/>
              <a:t>. **** denotes p&lt;0.0001.</a:t>
            </a:r>
          </a:p>
        </p:txBody>
      </p:sp>
    </p:spTree>
    <p:extLst>
      <p:ext uri="{BB962C8B-B14F-4D97-AF65-F5344CB8AC3E}">
        <p14:creationId xmlns:p14="http://schemas.microsoft.com/office/powerpoint/2010/main" val="2713075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DC4C262-E872-2E45-A163-AA5A73425A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1687" y="154863"/>
            <a:ext cx="5088625" cy="50886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919F7C0-D1F4-624F-9D69-A942BEF13F45}"/>
              </a:ext>
            </a:extLst>
          </p:cNvPr>
          <p:cNvSpPr txBox="1"/>
          <p:nvPr/>
        </p:nvSpPr>
        <p:spPr>
          <a:xfrm>
            <a:off x="2014152" y="5515337"/>
            <a:ext cx="8646662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. S2. Frequency of genetic alterations across disease groups of neuroendocrine tumors</a:t>
            </a:r>
            <a:endParaRPr lang="en-US" dirty="0"/>
          </a:p>
          <a:p>
            <a:r>
              <a:rPr lang="en-US" dirty="0" err="1"/>
              <a:t>gi</a:t>
            </a:r>
            <a:r>
              <a:rPr lang="en-US" dirty="0"/>
              <a:t>, gastrointestinal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23276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C7F6AFE-4BB8-794C-9FCC-0175DE16CD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4050" y="565874"/>
            <a:ext cx="5803900" cy="40132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E0C525A-D075-3344-AB2D-CB8F05AAC484}"/>
              </a:ext>
            </a:extLst>
          </p:cNvPr>
          <p:cNvSpPr txBox="1"/>
          <p:nvPr/>
        </p:nvSpPr>
        <p:spPr>
          <a:xfrm>
            <a:off x="2831658" y="4653022"/>
            <a:ext cx="652868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3. Impact of tumor purity on telomeric content</a:t>
            </a:r>
            <a:endParaRPr lang="en-US" dirty="0"/>
          </a:p>
          <a:p>
            <a:r>
              <a:rPr lang="en-US" dirty="0"/>
              <a:t>Boxplot showing the telomeric content of samples with alterations in </a:t>
            </a:r>
            <a:r>
              <a:rPr lang="en-US" i="1" dirty="0"/>
              <a:t>ATRX</a:t>
            </a:r>
            <a:r>
              <a:rPr lang="en-US" dirty="0"/>
              <a:t>, </a:t>
            </a:r>
            <a:r>
              <a:rPr lang="en-US" i="1" dirty="0"/>
              <a:t>DAXX</a:t>
            </a:r>
            <a:r>
              <a:rPr lang="en-US" dirty="0"/>
              <a:t> and </a:t>
            </a:r>
            <a:r>
              <a:rPr lang="en-US" i="1" dirty="0" err="1"/>
              <a:t>TERTp</a:t>
            </a:r>
            <a:r>
              <a:rPr lang="en-US" dirty="0"/>
              <a:t> across different tumor purities. *** denotes p&lt;0.001 and **** denotes p&lt;0.0001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16651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B8344FF-5231-2741-9AC1-B7C334D7E9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4350" y="624872"/>
            <a:ext cx="6083300" cy="39878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06DEF6A-B01A-F248-914A-58242F8278A5}"/>
              </a:ext>
            </a:extLst>
          </p:cNvPr>
          <p:cNvSpPr txBox="1"/>
          <p:nvPr/>
        </p:nvSpPr>
        <p:spPr>
          <a:xfrm>
            <a:off x="2622911" y="4745621"/>
            <a:ext cx="694617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4. Expression levels of RAD21 (A) and HGF (B) in PCAWG dataset</a:t>
            </a:r>
            <a:endParaRPr lang="en-US" dirty="0"/>
          </a:p>
          <a:p>
            <a:r>
              <a:rPr lang="en-US" dirty="0"/>
              <a:t>Plot showing expression levels of the indicated genes. Each dot is representative of one sample. * denotes p&lt;0.05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481193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78A8517-07A3-9748-8FB4-132B6A0B1D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9288" y="0"/>
            <a:ext cx="9053424" cy="579898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A70CAFD-59F8-894C-B1E3-43E42A52350C}"/>
              </a:ext>
            </a:extLst>
          </p:cNvPr>
          <p:cNvSpPr txBox="1"/>
          <p:nvPr/>
        </p:nvSpPr>
        <p:spPr>
          <a:xfrm>
            <a:off x="1458411" y="5683169"/>
            <a:ext cx="890093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5. Frequency of alterations across disease ontologies</a:t>
            </a:r>
            <a:endParaRPr lang="en-US" dirty="0"/>
          </a:p>
          <a:p>
            <a:r>
              <a:rPr lang="en-US" dirty="0" err="1"/>
              <a:t>Barplot</a:t>
            </a:r>
            <a:r>
              <a:rPr lang="en-US" dirty="0"/>
              <a:t> showing the percentage of samples with alterations in </a:t>
            </a:r>
            <a:r>
              <a:rPr lang="en-US" i="1" dirty="0"/>
              <a:t>ATRX</a:t>
            </a:r>
            <a:r>
              <a:rPr lang="en-US" dirty="0"/>
              <a:t>, </a:t>
            </a:r>
            <a:r>
              <a:rPr lang="en-US" i="1" dirty="0"/>
              <a:t>DAXX</a:t>
            </a:r>
            <a:r>
              <a:rPr lang="en-US" dirty="0"/>
              <a:t>, </a:t>
            </a:r>
            <a:r>
              <a:rPr lang="en-US" i="1" dirty="0"/>
              <a:t>TERC</a:t>
            </a:r>
            <a:r>
              <a:rPr lang="en-US" dirty="0"/>
              <a:t>, </a:t>
            </a:r>
            <a:r>
              <a:rPr lang="en-US" i="1" dirty="0" err="1"/>
              <a:t>TERTp</a:t>
            </a:r>
            <a:r>
              <a:rPr lang="en-US" dirty="0"/>
              <a:t>,</a:t>
            </a:r>
            <a:r>
              <a:rPr lang="en-US" i="1" dirty="0"/>
              <a:t> RAD21</a:t>
            </a:r>
            <a:r>
              <a:rPr lang="en-US" dirty="0"/>
              <a:t>, and</a:t>
            </a:r>
            <a:r>
              <a:rPr lang="en-US" i="1" dirty="0"/>
              <a:t> HGF </a:t>
            </a:r>
            <a:r>
              <a:rPr lang="en-US" dirty="0"/>
              <a:t>across disease ontologies. Analysis was restricted to disease ontologies with more than 40 sample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5802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99</Words>
  <Application>Microsoft Macintosh PowerPoint</Application>
  <PresentationFormat>Widescreen</PresentationFormat>
  <Paragraphs>1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 Albacker</dc:creator>
  <cp:lastModifiedBy>Lee Albacker</cp:lastModifiedBy>
  <cp:revision>1</cp:revision>
  <dcterms:created xsi:type="dcterms:W3CDTF">2022-02-04T02:35:08Z</dcterms:created>
  <dcterms:modified xsi:type="dcterms:W3CDTF">2022-02-04T02:41:10Z</dcterms:modified>
</cp:coreProperties>
</file>